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66" y="-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8874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87329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5665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6346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1217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23606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0453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1886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5740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3556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9199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61CB4-405F-4F85-B367-77B48338B6D5}" type="datetimeFigureOut">
              <a:rPr lang="en-AU" smtClean="0"/>
              <a:t>20/11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9ECD8-9487-4A83-A190-862482D04BF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94553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AU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</a:t>
            </a:r>
            <a:r>
              <a:rPr lang="en-A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relationships among cation diffusion facilitator 8.</a:t>
            </a:r>
            <a:endParaRPr lang="en-A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0555" y="2420888"/>
            <a:ext cx="7664358" cy="2265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04280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9BB73D8-C175-4385-8681-D121B1826FF2}">
  <ds:schemaRefs>
    <ds:schemaRef ds:uri="http://purl.org/dc/elements/1.1/"/>
    <ds:schemaRef ds:uri="http://purl.org/dc/dcmitype/"/>
    <ds:schemaRef ds:uri="http://schemas.microsoft.com/office/2006/documentManagement/types"/>
    <ds:schemaRef ds:uri="http://www.w3.org/XML/1998/namespace"/>
    <ds:schemaRef ds:uri="http://schemas.microsoft.com/office/2006/metadata/properties"/>
    <ds:schemaRef ds:uri="http://schemas.openxmlformats.org/package/2006/metadata/core-properties"/>
    <ds:schemaRef ds:uri="28de4f29-e3d9-478e-b05a-16a8ff0eb393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B23608D8-13BB-4BE2-9195-6BE4E3D7573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8de4f29-e3d9-478e-b05a-16a8ff0eb393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3.xml><?xml version="1.0" encoding="utf-8"?>
<ds:datastoreItem xmlns:ds="http://schemas.openxmlformats.org/officeDocument/2006/customXml" ds:itemID="{0D996FD3-A513-4029-8792-C796B0E4848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95</TotalTime>
  <Words>1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upplementary Figure 3: Phylogenetic relationships among cation diffusion facilitator 8.</vt:lpstr>
    </vt:vector>
  </TitlesOfParts>
  <Company>NSW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tt Mcvittie</dc:creator>
  <cp:lastModifiedBy>NSW Government User</cp:lastModifiedBy>
  <cp:revision>32</cp:revision>
  <dcterms:created xsi:type="dcterms:W3CDTF">2017-08-15T00:38:58Z</dcterms:created>
  <dcterms:modified xsi:type="dcterms:W3CDTF">2017-11-20T03:47:08Z</dcterms:modified>
</cp:coreProperties>
</file>